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60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8CF05-75CE-D81B-3958-011A73ED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0A9B5-4BAF-AA20-AD4F-544556872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A4643-CEAB-ED4A-81F1-B042D4092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0ED0D-4A3D-4FAA-F91B-CD55D9E1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2B51B-2E43-599A-6838-96430361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5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73E9B-D4E7-E346-FB50-A41E0B8EF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8F6E18-6FA5-C8C9-870D-6A40E72E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A1AC-85A5-56DF-9A62-FAA70B931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957D5-0C61-5DC0-82FB-9F74D60D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46975-8E45-40EA-B91B-BBA29D679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D2956C-9585-C3A7-A934-74CA05A15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E2285-6BCE-8D45-2114-06BAE74C2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A9F5-51A9-258E-4259-FFF32975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9E6E3-3081-0DF3-9135-FED78B97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8B459-4246-5546-2666-46848F6AA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8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12D5-92DA-D71D-E7FF-1185C57EF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3AC3-5838-5686-979F-C4708EAB9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BCBBE-C65A-1D9B-06AB-5A829171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BD418-50AA-195E-9EF7-D37BD964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3E518-5ACE-5576-44E5-BE929C49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AAB84-091F-22D5-3A6C-2DC3AAC4C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6B9BA-F627-D1E2-DB31-4985C5D27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E6CB2-E836-6A59-C64E-F2318B43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1097C-65E4-6523-D969-7CCE35A7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D516-7B6B-8815-EB85-192C470E3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0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145D4-4F3E-DEF0-E52D-6F199945E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7D364-D78F-5285-CFE5-28351C6CC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EEA0D-DFDD-70C7-2A63-AED7EAD1A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DA67F-4A1E-0861-4C09-6E66646B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E79AA-DD26-89CD-01CC-9892E8406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6D811C-07A8-0FBC-47D4-89DD4BA7B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9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4007-89BB-BD77-871F-B1AA48E1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168E8-01A6-B85D-F9AE-23C401953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D23E6-9139-D575-2CCF-25C664743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9A8250-CF1B-3354-0556-08C73340F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5D328-D506-2928-BAF0-05A9108B5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F467DC-86FD-CA63-923D-03A7C1B09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4FF3B5-B688-9692-22E2-A444F44C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7691A-9CD4-1274-14E1-AC55E5585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07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6D0E-AD11-EA47-B1DC-01D7E0AA5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D4909-405A-165D-103C-1D7E95FD7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D9572-0B1D-FE6F-EF95-F5E64844D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EEC9F-7990-93B9-A120-28D153D8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03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903C99-819D-1F44-9492-14328391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3F52CA-9FF0-30C6-E2D9-60B1E91C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E4D404-9C29-4F76-6AAF-687EEF66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4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56EAF-B526-28C9-72E1-15BAA3BE8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04110-9824-D35B-CF74-FFAA3E956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DC3187-603B-0CAB-38C7-E86921C0E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FA8D5-E6AF-0212-F67F-ACFA6DFF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AD6B2-B43E-F50B-56D6-3F5269625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16575-FF07-F808-8E6F-44012E5A0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55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2E2D0-C57B-03DC-8B59-6147D3F05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6B405-2A04-9B3F-CAFC-16C4178268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BA778B-0D30-1763-F06E-00B2F19EF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BFAF-71E0-16DE-2FD1-F17396541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6507B-296A-BE8A-004A-9B9C54CF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94F8C-3B05-AC5F-D984-D5693E3A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4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508D78-3907-9E1F-6C27-99B43B6D1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EB8E4-6EFD-207A-B4BB-B6258EB5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A7D4-7F64-B9D1-8B5C-9FF21ADE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C2518-AE36-48D1-96F6-74333C097C54}" type="datetimeFigureOut">
              <a:rPr lang="en-GB" smtClean="0"/>
              <a:t>0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2A2B5-108F-6F70-32EE-A377B5418F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33AA-3D25-AA0B-0995-A503FFCDF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5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1593751" y="155931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2424702" y="1559312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5348129" y="1282313"/>
            <a:ext cx="5437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F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254318-9923-99B2-2653-E7AE07F94C65}"/>
              </a:ext>
            </a:extLst>
          </p:cNvPr>
          <p:cNvSpPr txBox="1"/>
          <p:nvPr/>
        </p:nvSpPr>
        <p:spPr>
          <a:xfrm>
            <a:off x="4118851" y="1282313"/>
            <a:ext cx="6463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88B99FD-8DF4-16A7-4BEA-8E453307D2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3882779" y="3111289"/>
            <a:ext cx="3600000" cy="123471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E64E964-3EE8-0E29-7FE2-79DBC814E2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624702" y="2600786"/>
            <a:ext cx="3600000" cy="242584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B9E6A97-C983-D253-50DF-DF17195292E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2608664" y="3321411"/>
            <a:ext cx="3384000" cy="1195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47443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1240231" y="155567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2154572" y="1556119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E390-5396-151B-3669-F68D32BDDCB7}"/>
              </a:ext>
            </a:extLst>
          </p:cNvPr>
          <p:cNvSpPr txBox="1"/>
          <p:nvPr/>
        </p:nvSpPr>
        <p:spPr>
          <a:xfrm>
            <a:off x="3841326" y="1310893"/>
            <a:ext cx="6463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F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4997301" y="1296603"/>
            <a:ext cx="5437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75406E6A-841C-802C-BD9B-D6580302E0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3450976" y="3177628"/>
            <a:ext cx="3636387" cy="113115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55250382-E218-5D9D-A84D-EC9D3D192D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8871" y="1925010"/>
            <a:ext cx="3884722" cy="38963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0925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1312378" y="157360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2243626" y="1538481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9DE390-5396-151B-3669-F68D32BDDCB7}"/>
              </a:ext>
            </a:extLst>
          </p:cNvPr>
          <p:cNvSpPr txBox="1"/>
          <p:nvPr/>
        </p:nvSpPr>
        <p:spPr>
          <a:xfrm>
            <a:off x="3645230" y="1296603"/>
            <a:ext cx="6463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AF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4958829" y="1296603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hDF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254318-9923-99B2-2653-E7AE07F94C65}"/>
              </a:ext>
            </a:extLst>
          </p:cNvPr>
          <p:cNvSpPr txBox="1"/>
          <p:nvPr/>
        </p:nvSpPr>
        <p:spPr>
          <a:xfrm>
            <a:off x="6333244" y="1282313"/>
            <a:ext cx="5437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1BF27BC-116E-2B5B-2B58-EDF2EAC3D8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4885979" y="3138665"/>
            <a:ext cx="3600000" cy="117995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20A6AA5-92A7-57EC-049B-0F51C0440F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7798" y="1942934"/>
            <a:ext cx="1179958" cy="230676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D7BDF33-38D9-F4E3-27CC-AD854457E5B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1557632" y="1280594"/>
            <a:ext cx="2417216" cy="36314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17035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1593751" y="155931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2424702" y="1559312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3797468" y="1282313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hDF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AC64DDC-E455-E72D-4FF9-63C2A0F176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7511" y="1928643"/>
            <a:ext cx="3696433" cy="2449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1816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4508211-2629-55DA-13C9-ECF99EB75C2B}"/>
              </a:ext>
            </a:extLst>
          </p:cNvPr>
          <p:cNvSpPr txBox="1"/>
          <p:nvPr/>
        </p:nvSpPr>
        <p:spPr>
          <a:xfrm>
            <a:off x="1524925" y="1559312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2424702" y="1559312"/>
            <a:ext cx="1111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5352A3-1EAE-AA67-1291-F58FFBAE8132}"/>
              </a:ext>
            </a:extLst>
          </p:cNvPr>
          <p:cNvSpPr txBox="1"/>
          <p:nvPr/>
        </p:nvSpPr>
        <p:spPr>
          <a:xfrm>
            <a:off x="3859582" y="1282312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M</a:t>
            </a:r>
          </a:p>
          <a:p>
            <a:pPr algn="ctr"/>
            <a:r>
              <a:rPr lang="en-GB" dirty="0" err="1">
                <a:latin typeface="Arial" panose="020B0604020202020204" pitchFamily="34" charset="0"/>
                <a:cs typeface="Arial" panose="020B0604020202020204" pitchFamily="34" charset="0"/>
              </a:rPr>
              <a:t>hDF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5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9EEEAAF-1A66-8EDA-243F-D7292388DA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0914" y="1928643"/>
            <a:ext cx="3561293" cy="23483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7299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</TotalTime>
  <Words>43</Words>
  <Application>Microsoft Office PowerPoint</Application>
  <PresentationFormat>Widescreen</PresentationFormat>
  <Paragraphs>3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12</cp:revision>
  <dcterms:created xsi:type="dcterms:W3CDTF">2024-06-06T16:34:22Z</dcterms:created>
  <dcterms:modified xsi:type="dcterms:W3CDTF">2024-06-07T16:29:53Z</dcterms:modified>
</cp:coreProperties>
</file>